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B93"/>
    <a:srgbClr val="FFC8C5"/>
    <a:srgbClr val="FF3300"/>
    <a:srgbClr val="F6882E"/>
    <a:srgbClr val="FAB8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0279" autoAdjust="0"/>
    <p:restoredTop sz="99815" autoAdjust="0"/>
  </p:normalViewPr>
  <p:slideViewPr>
    <p:cSldViewPr showGuides="1">
      <p:cViewPr>
        <p:scale>
          <a:sx n="77" d="100"/>
          <a:sy n="77" d="100"/>
        </p:scale>
        <p:origin x="-2286" y="666"/>
      </p:cViewPr>
      <p:guideLst>
        <p:guide orient="horz" pos="4445"/>
        <p:guide pos="254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7519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1009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7637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1899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4486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1152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154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9232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5299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24573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057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6ABF4-75E2-45D3-872D-A3ABCD8A6BB7}" type="datetimeFigureOut">
              <a:rPr lang="es-ES" smtClean="0"/>
              <a:t>29/12/2018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8E388-2AC0-4599-BA8D-0BE02EDC2B7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59640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9356" y="71500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S1 </a:t>
            </a:r>
            <a:r>
              <a:rPr lang="es-ES" b="1" dirty="0" err="1" smtClean="0"/>
              <a:t>Table</a:t>
            </a:r>
            <a:endParaRPr lang="es-ES" b="1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7586926"/>
              </p:ext>
            </p:extLst>
          </p:nvPr>
        </p:nvGraphicFramePr>
        <p:xfrm>
          <a:off x="332654" y="611560"/>
          <a:ext cx="6084678" cy="526796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1014113"/>
                <a:gridCol w="1014113"/>
                <a:gridCol w="1014113"/>
                <a:gridCol w="1014113"/>
                <a:gridCol w="1014113"/>
                <a:gridCol w="1014113"/>
              </a:tblGrid>
              <a:tr h="370840">
                <a:tc gridSpan="4">
                  <a:txBody>
                    <a:bodyPr/>
                    <a:lstStyle/>
                    <a:p>
                      <a:pPr algn="ctr"/>
                      <a:r>
                        <a:rPr lang="es-ES" sz="1400" dirty="0" err="1" smtClean="0"/>
                        <a:t>Whole</a:t>
                      </a:r>
                      <a:r>
                        <a:rPr lang="es-ES" sz="1400" dirty="0" smtClean="0"/>
                        <a:t> </a:t>
                      </a:r>
                      <a:r>
                        <a:rPr lang="es-ES" sz="1400" dirty="0" err="1" smtClean="0"/>
                        <a:t>Blood</a:t>
                      </a:r>
                      <a:endParaRPr lang="en-US" sz="14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s-ES" sz="1400" dirty="0" smtClean="0"/>
                        <a:t>Intracelular </a:t>
                      </a:r>
                      <a:r>
                        <a:rPr lang="es-ES" sz="1400" dirty="0" err="1" smtClean="0"/>
                        <a:t>labeling</a:t>
                      </a:r>
                      <a:endParaRPr lang="en-US" sz="14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b="1" dirty="0" smtClean="0"/>
                        <a:t>B</a:t>
                      </a:r>
                      <a:r>
                        <a:rPr lang="es-ES" sz="1100" b="1" baseline="0" dirty="0" smtClean="0"/>
                        <a:t> </a:t>
                      </a:r>
                      <a:r>
                        <a:rPr lang="es-ES" sz="1100" b="1" baseline="0" dirty="0" err="1" smtClean="0"/>
                        <a:t>cells</a:t>
                      </a:r>
                      <a:r>
                        <a:rPr lang="es-ES" sz="1100" b="1" baseline="0" dirty="0" smtClean="0"/>
                        <a:t> and </a:t>
                      </a:r>
                      <a:r>
                        <a:rPr lang="es-ES" sz="1100" b="1" baseline="0" dirty="0" err="1" smtClean="0"/>
                        <a:t>Breg</a:t>
                      </a:r>
                      <a:r>
                        <a:rPr lang="es-ES" sz="1100" b="1" baseline="0" dirty="0" smtClean="0"/>
                        <a:t> panel</a:t>
                      </a:r>
                      <a:endParaRPr lang="en-US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dirty="0" smtClean="0"/>
                        <a:t>CD4, CD8 and</a:t>
                      </a:r>
                      <a:r>
                        <a:rPr lang="es-ES" sz="1100" b="1" baseline="0" dirty="0" smtClean="0"/>
                        <a:t> </a:t>
                      </a:r>
                      <a:r>
                        <a:rPr lang="es-ES" sz="1100" b="1" dirty="0" err="1" smtClean="0"/>
                        <a:t>Treg</a:t>
                      </a:r>
                      <a:r>
                        <a:rPr lang="es-ES" sz="1100" b="1" dirty="0" smtClean="0"/>
                        <a:t> panel</a:t>
                      </a:r>
                      <a:endParaRPr lang="en-US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dirty="0" smtClean="0"/>
                        <a:t>TIM-1 panel</a:t>
                      </a:r>
                      <a:endParaRPr lang="en-US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dirty="0" smtClean="0"/>
                        <a:t>PD-1 and PD-L1 panel</a:t>
                      </a:r>
                      <a:endParaRPr lang="en-US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dirty="0" err="1" smtClean="0"/>
                        <a:t>Treg</a:t>
                      </a:r>
                      <a:r>
                        <a:rPr lang="es-ES" sz="1100" b="1" dirty="0" smtClean="0"/>
                        <a:t>/Foxp3 panel</a:t>
                      </a:r>
                      <a:endParaRPr lang="en-US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b="1" dirty="0" smtClean="0"/>
                        <a:t>IL-10 panel</a:t>
                      </a:r>
                      <a:endParaRPr lang="en-US" sz="1100" b="1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38-FITC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45RA-FITC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72-FITC</a:t>
                      </a:r>
                      <a:r>
                        <a:rPr lang="es-ES" sz="1100" baseline="30000" dirty="0" smtClean="0"/>
                        <a:t>(b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XCR5-Alexa488</a:t>
                      </a:r>
                      <a:r>
                        <a:rPr lang="es-ES" sz="1100" baseline="30000" dirty="0" smtClean="0"/>
                        <a:t>(c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27-FITC</a:t>
                      </a:r>
                      <a:r>
                        <a:rPr lang="es-ES" sz="1100" baseline="30000" dirty="0" smtClean="0"/>
                        <a:t>(b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38-FITC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27-PE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127-PE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100-PE</a:t>
                      </a:r>
                      <a:r>
                        <a:rPr lang="es-ES" sz="1100" baseline="30000" dirty="0" smtClean="0"/>
                        <a:t>(b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PD-1-PE</a:t>
                      </a:r>
                      <a:r>
                        <a:rPr lang="es-ES" sz="1100" baseline="30000" dirty="0" smtClean="0"/>
                        <a:t>(c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Foxp3-PE</a:t>
                      </a:r>
                      <a:r>
                        <a:rPr lang="es-ES" sz="1100" baseline="30000" dirty="0" smtClean="0"/>
                        <a:t>(f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dirty="0" smtClean="0"/>
                        <a:t>CD27-PE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 smtClean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5-ECD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45RO-ECD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5-ECD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19-ECD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45RA-ECD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24-PC5.5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27-PC5.5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45RO-PC5.5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dirty="0" smtClean="0"/>
                        <a:t>CD24-PC5.5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 smtClean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1d-PC7</a:t>
                      </a:r>
                      <a:r>
                        <a:rPr lang="es-ES" sz="1100" baseline="30000" dirty="0" smtClean="0"/>
                        <a:t>(b)</a:t>
                      </a:r>
                      <a:endParaRPr lang="en-US" sz="11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25-PC7</a:t>
                      </a:r>
                      <a:r>
                        <a:rPr lang="es-ES" sz="1100" baseline="30000" dirty="0" smtClean="0"/>
                        <a:t>(c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dirty="0" smtClean="0"/>
                        <a:t>CD1d-PC7</a:t>
                      </a:r>
                      <a:r>
                        <a:rPr lang="es-ES" sz="1100" baseline="30000" dirty="0" smtClean="0"/>
                        <a:t>(b)</a:t>
                      </a:r>
                      <a:endParaRPr lang="en-US" sz="11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4-PC7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27-PC7</a:t>
                      </a:r>
                      <a:r>
                        <a:rPr lang="es-ES" sz="1100" baseline="30000" dirty="0" smtClean="0"/>
                        <a:t>(f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PD-L1-APC</a:t>
                      </a:r>
                      <a:r>
                        <a:rPr lang="es-ES" sz="1100" baseline="30000" dirty="0" smtClean="0"/>
                        <a:t>(c)</a:t>
                      </a:r>
                      <a:endParaRPr lang="en-US" sz="11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HLA-DR-APC</a:t>
                      </a:r>
                      <a:r>
                        <a:rPr lang="es-ES" sz="1100" baseline="30000" dirty="0" smtClean="0"/>
                        <a:t>(d)</a:t>
                      </a:r>
                      <a:endParaRPr lang="en-US" sz="11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TIM1-Alexa647</a:t>
                      </a:r>
                      <a:r>
                        <a:rPr lang="es-ES" sz="1100" baseline="30000" dirty="0" smtClean="0"/>
                        <a:t>(c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dirty="0" smtClean="0"/>
                        <a:t>PD-L1-APC</a:t>
                      </a:r>
                      <a:r>
                        <a:rPr lang="es-ES" sz="1100" baseline="30000" dirty="0" smtClean="0"/>
                        <a:t>(c)</a:t>
                      </a:r>
                      <a:endParaRPr lang="en-US" sz="11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IL-10-APC</a:t>
                      </a:r>
                      <a:r>
                        <a:rPr lang="es-ES" sz="1100" baseline="30000" dirty="0" smtClean="0"/>
                        <a:t>(e)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3-APC/Cy.5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38-APC/Cy5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38-APC/Cy5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4-APC/Cy7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dirty="0" smtClean="0"/>
                        <a:t>CD4-APC/Cy7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dirty="0" smtClean="0"/>
                        <a:t>CD4-APC/Cy7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VD-eFluor780</a:t>
                      </a:r>
                      <a:r>
                        <a:rPr lang="es-ES" sz="1100" baseline="30000" dirty="0" smtClean="0"/>
                        <a:t>(f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8-PB</a:t>
                      </a:r>
                      <a:r>
                        <a:rPr lang="es-ES" sz="1100" baseline="30000" dirty="0" smtClean="0"/>
                        <a:t>(b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dirty="0" smtClean="0"/>
                        <a:t>CD8-PB</a:t>
                      </a:r>
                      <a:r>
                        <a:rPr lang="es-ES" sz="1100" baseline="30000" dirty="0" smtClean="0"/>
                        <a:t>(b)</a:t>
                      </a:r>
                      <a:endParaRPr lang="en-US" sz="11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8-PB</a:t>
                      </a:r>
                      <a:r>
                        <a:rPr lang="es-ES" sz="1100" baseline="30000" dirty="0" smtClean="0"/>
                        <a:t>(b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dirty="0" smtClean="0"/>
                        <a:t>CD8-PB</a:t>
                      </a:r>
                      <a:r>
                        <a:rPr lang="es-ES" sz="1100" baseline="30000" dirty="0" smtClean="0"/>
                        <a:t>(b)</a:t>
                      </a:r>
                      <a:endParaRPr lang="en-US" sz="11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HLA-DR-PB</a:t>
                      </a:r>
                      <a:r>
                        <a:rPr lang="es-ES" sz="1100" baseline="30000" dirty="0" smtClean="0"/>
                        <a:t>(f)</a:t>
                      </a:r>
                      <a:endParaRPr lang="en-US" sz="11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VD-eFluor450</a:t>
                      </a:r>
                      <a:r>
                        <a:rPr lang="es-ES" sz="1100" baseline="30000" dirty="0" smtClean="0"/>
                        <a:t>(f)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19-KO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3-PO</a:t>
                      </a:r>
                      <a:r>
                        <a:rPr lang="es-ES" sz="1100" baseline="30000" dirty="0" smtClean="0"/>
                        <a:t>(e)</a:t>
                      </a:r>
                      <a:endParaRPr lang="en-US" sz="1100" baseline="30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19-KO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3-PO</a:t>
                      </a:r>
                      <a:r>
                        <a:rPr lang="es-ES" sz="1100" baseline="30000" dirty="0" smtClean="0"/>
                        <a:t>(e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100" dirty="0" smtClean="0"/>
                        <a:t>CD3-PO</a:t>
                      </a:r>
                      <a:r>
                        <a:rPr lang="es-ES" sz="1100" baseline="30000" dirty="0" smtClean="0"/>
                        <a:t>(e)</a:t>
                      </a:r>
                      <a:endParaRPr lang="en-US" sz="110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D19-KO</a:t>
                      </a:r>
                      <a:r>
                        <a:rPr lang="es-ES" sz="1100" baseline="30000" dirty="0" smtClean="0"/>
                        <a:t>(a)</a:t>
                      </a:r>
                      <a:endParaRPr lang="en-US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AL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AL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AL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CAL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100" dirty="0" smtClean="0"/>
                        <a:t>-</a:t>
                      </a:r>
                      <a:endParaRPr lang="en-US" sz="1100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424114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42</TotalTime>
  <Words>143</Words>
  <Application>Microsoft Office PowerPoint</Application>
  <PresentationFormat>On-screen Show (4:3)</PresentationFormat>
  <Paragraphs>7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jorie Pion</dc:creator>
  <cp:lastModifiedBy>Marjorie Pion</cp:lastModifiedBy>
  <cp:revision>302</cp:revision>
  <cp:lastPrinted>2018-07-26T07:47:16Z</cp:lastPrinted>
  <dcterms:created xsi:type="dcterms:W3CDTF">2016-12-20T15:13:27Z</dcterms:created>
  <dcterms:modified xsi:type="dcterms:W3CDTF">2018-12-29T17:03:05Z</dcterms:modified>
</cp:coreProperties>
</file>